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60" r:id="rId4"/>
    <p:sldId id="261" r:id="rId5"/>
    <p:sldId id="262" r:id="rId6"/>
    <p:sldId id="263" r:id="rId7"/>
    <p:sldId id="264" r:id="rId8"/>
    <p:sldId id="265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Objects="1">
      <p:cViewPr varScale="1">
        <p:scale>
          <a:sx n="83" d="100"/>
          <a:sy n="83" d="100"/>
        </p:scale>
        <p:origin x="-109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57607" cy="57607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898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255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825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508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537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900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692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490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2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44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36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1A3F8-35DA-43DD-A2D2-8180445D95F8}" type="datetimeFigureOut">
              <a:rPr lang="en-US" smtClean="0"/>
              <a:t>10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E0E6E-A75E-4998-A40F-C2FADA56B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669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4375363"/>
              </p:ext>
            </p:extLst>
          </p:nvPr>
        </p:nvGraphicFramePr>
        <p:xfrm>
          <a:off x="3792665" y="557776"/>
          <a:ext cx="2057399" cy="2225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2982"/>
                <a:gridCol w="1054417"/>
              </a:tblGrid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POS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POS2 </a:t>
                      </a:r>
                      <a:endParaRPr lang="en-US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2 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4</a:t>
                      </a:r>
                      <a:endParaRPr lang="en-US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5 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6 </a:t>
                      </a:r>
                      <a:endParaRPr lang="en-US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8 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10 </a:t>
                      </a:r>
                      <a:endParaRPr lang="en-US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IL-13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GM-CSF 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b="0" dirty="0" smtClean="0"/>
                        <a:t>IFN</a:t>
                      </a:r>
                      <a:r>
                        <a:rPr lang="el-GR" b="0" dirty="0" smtClean="0">
                          <a:latin typeface="Arial"/>
                          <a:cs typeface="Arial"/>
                        </a:rPr>
                        <a:t>γ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 smtClean="0"/>
                        <a:t>TNF</a:t>
                      </a:r>
                      <a:r>
                        <a:rPr lang="el-GR" b="0" dirty="0" smtClean="0">
                          <a:latin typeface="Arial"/>
                          <a:cs typeface="Arial"/>
                        </a:rPr>
                        <a:t>α</a:t>
                      </a:r>
                      <a:endParaRPr lang="en-US" b="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076" name="Picture 4" descr="C:\Users\gmscyc\Desktop\Crystal\Raybiotech\750_(#1_532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03354" y="557776"/>
            <a:ext cx="1527311" cy="4953000"/>
          </a:xfrm>
          <a:prstGeom prst="rect">
            <a:avLst/>
          </a:prstGeom>
          <a:noFill/>
        </p:spPr>
      </p:pic>
      <p:sp>
        <p:nvSpPr>
          <p:cNvPr id="7" name="Right Brace 6"/>
          <p:cNvSpPr/>
          <p:nvPr/>
        </p:nvSpPr>
        <p:spPr>
          <a:xfrm>
            <a:off x="3106864" y="557776"/>
            <a:ext cx="76200" cy="5334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3259264" y="633976"/>
            <a:ext cx="457200" cy="152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259264" y="862576"/>
            <a:ext cx="457200" cy="1905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1066800" y="304800"/>
            <a:ext cx="5867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                                            B			            C</a:t>
            </a:r>
          </a:p>
        </p:txBody>
      </p:sp>
      <p:grpSp>
        <p:nvGrpSpPr>
          <p:cNvPr id="2" name="Group 54"/>
          <p:cNvGrpSpPr/>
          <p:nvPr/>
        </p:nvGrpSpPr>
        <p:grpSpPr>
          <a:xfrm>
            <a:off x="6764464" y="405376"/>
            <a:ext cx="1600200" cy="5181600"/>
            <a:chOff x="7010400" y="838200"/>
            <a:chExt cx="1600200" cy="5181600"/>
          </a:xfrm>
        </p:grpSpPr>
        <p:grpSp>
          <p:nvGrpSpPr>
            <p:cNvPr id="3" name="Group 8"/>
            <p:cNvGrpSpPr/>
            <p:nvPr/>
          </p:nvGrpSpPr>
          <p:grpSpPr>
            <a:xfrm>
              <a:off x="7010400" y="838200"/>
              <a:ext cx="1600200" cy="5181600"/>
              <a:chOff x="304800" y="685800"/>
              <a:chExt cx="1600200" cy="5181600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304800" y="685800"/>
                <a:ext cx="1600200" cy="5181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4" name="Group 16"/>
              <p:cNvGrpSpPr/>
              <p:nvPr/>
            </p:nvGrpSpPr>
            <p:grpSpPr>
              <a:xfrm>
                <a:off x="446183" y="806068"/>
                <a:ext cx="1329370" cy="533400"/>
                <a:chOff x="435166" y="762000"/>
                <a:chExt cx="1329370" cy="533400"/>
              </a:xfrm>
            </p:grpSpPr>
            <p:sp>
              <p:nvSpPr>
                <p:cNvPr id="36" name="Rectangle 35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7" name="Rectangle 36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6" name="Group 18"/>
              <p:cNvGrpSpPr/>
              <p:nvPr/>
            </p:nvGrpSpPr>
            <p:grpSpPr>
              <a:xfrm>
                <a:off x="436085" y="1426685"/>
                <a:ext cx="1329370" cy="533400"/>
                <a:chOff x="435166" y="762000"/>
                <a:chExt cx="1329370" cy="533400"/>
              </a:xfrm>
            </p:grpSpPr>
            <p:sp>
              <p:nvSpPr>
                <p:cNvPr id="34" name="Rectangle 33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8" name="Group 21"/>
              <p:cNvGrpSpPr/>
              <p:nvPr/>
            </p:nvGrpSpPr>
            <p:grpSpPr>
              <a:xfrm>
                <a:off x="435166" y="2037204"/>
                <a:ext cx="1329370" cy="533400"/>
                <a:chOff x="435166" y="762000"/>
                <a:chExt cx="1329370" cy="533400"/>
              </a:xfrm>
            </p:grpSpPr>
            <p:sp>
              <p:nvSpPr>
                <p:cNvPr id="32" name="Rectangle 31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3" name="Rectangle 32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9" name="Group 24"/>
              <p:cNvGrpSpPr/>
              <p:nvPr/>
            </p:nvGrpSpPr>
            <p:grpSpPr>
              <a:xfrm>
                <a:off x="436085" y="2690872"/>
                <a:ext cx="1329370" cy="533400"/>
                <a:chOff x="435166" y="762000"/>
                <a:chExt cx="1329370" cy="533400"/>
              </a:xfrm>
            </p:grpSpPr>
            <p:sp>
              <p:nvSpPr>
                <p:cNvPr id="30" name="Rectangle 29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4" name="Group 27"/>
              <p:cNvGrpSpPr/>
              <p:nvPr/>
            </p:nvGrpSpPr>
            <p:grpSpPr>
              <a:xfrm>
                <a:off x="446183" y="3341783"/>
                <a:ext cx="1329370" cy="533400"/>
                <a:chOff x="435166" y="762000"/>
                <a:chExt cx="1329370" cy="533400"/>
              </a:xfrm>
            </p:grpSpPr>
            <p:sp>
              <p:nvSpPr>
                <p:cNvPr id="28" name="Rectangle 27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9" name="Rectangle 28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5" name="Group 30"/>
              <p:cNvGrpSpPr/>
              <p:nvPr/>
            </p:nvGrpSpPr>
            <p:grpSpPr>
              <a:xfrm>
                <a:off x="436085" y="3962400"/>
                <a:ext cx="1329370" cy="533400"/>
                <a:chOff x="435166" y="762000"/>
                <a:chExt cx="1329370" cy="533400"/>
              </a:xfrm>
            </p:grpSpPr>
            <p:sp>
              <p:nvSpPr>
                <p:cNvPr id="26" name="Rectangle 25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7" name="Rectangle 26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6" name="Group 33"/>
              <p:cNvGrpSpPr/>
              <p:nvPr/>
            </p:nvGrpSpPr>
            <p:grpSpPr>
              <a:xfrm>
                <a:off x="435166" y="4572919"/>
                <a:ext cx="1329370" cy="533400"/>
                <a:chOff x="435166" y="762000"/>
                <a:chExt cx="1329370" cy="533400"/>
              </a:xfrm>
            </p:grpSpPr>
            <p:sp>
              <p:nvSpPr>
                <p:cNvPr id="24" name="Rectangle 23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" name="Group 36"/>
              <p:cNvGrpSpPr/>
              <p:nvPr/>
            </p:nvGrpSpPr>
            <p:grpSpPr>
              <a:xfrm>
                <a:off x="436085" y="5226587"/>
                <a:ext cx="1329370" cy="533400"/>
                <a:chOff x="435166" y="762000"/>
                <a:chExt cx="1329370" cy="533400"/>
              </a:xfrm>
            </p:grpSpPr>
            <p:sp>
              <p:nvSpPr>
                <p:cNvPr id="22" name="Rectangle 21"/>
                <p:cNvSpPr/>
                <p:nvPr/>
              </p:nvSpPr>
              <p:spPr>
                <a:xfrm>
                  <a:off x="43516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1154936" y="762000"/>
                  <a:ext cx="609600" cy="5334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38" name="TextBox 37"/>
            <p:cNvSpPr txBox="1"/>
            <p:nvPr/>
          </p:nvSpPr>
          <p:spPr>
            <a:xfrm>
              <a:off x="7042532" y="1001617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761383" y="1001617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032434" y="1617769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750366" y="1622234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031515" y="2233921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5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749447" y="2238386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032434" y="2876572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tandard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7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750366" y="2980190"/>
              <a:ext cx="838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NTR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043451" y="3539419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CF10A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ock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772400" y="3538251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CF10A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ock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042532" y="4154403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CF10A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l-GR" sz="10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771481" y="4153235"/>
              <a:ext cx="838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CF10A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l-GR" sz="10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043451" y="4736585"/>
              <a:ext cx="8382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DA-MB-231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ock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7772400" y="4735417"/>
              <a:ext cx="8382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DA-MB-231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ock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042532" y="5394718"/>
              <a:ext cx="8382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DA-MB-231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l-GR" sz="10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771481" y="5393550"/>
              <a:ext cx="8382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DA-MB-231</a:t>
              </a:r>
            </a:p>
            <a:p>
              <a:pPr algn="ct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l-GR" sz="10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6" name="Rectangle 55"/>
          <p:cNvSpPr/>
          <p:nvPr/>
        </p:nvSpPr>
        <p:spPr>
          <a:xfrm>
            <a:off x="304800" y="5751493"/>
            <a:ext cx="84582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Figure S1.</a:t>
            </a:r>
            <a:r>
              <a:rPr lang="en-US" sz="1400" dirty="0"/>
              <a:t> </a:t>
            </a:r>
            <a:r>
              <a:rPr lang="en-US" sz="1400" b="1" dirty="0"/>
              <a:t>Human TH1/TH2 array 1.</a:t>
            </a:r>
            <a:r>
              <a:rPr lang="en-US" sz="1400" dirty="0"/>
              <a:t> (A) A full </a:t>
            </a:r>
            <a:r>
              <a:rPr lang="en-US" sz="1400" dirty="0" err="1"/>
              <a:t>Quantibody</a:t>
            </a:r>
            <a:r>
              <a:rPr lang="en-US" sz="1400" dirty="0"/>
              <a:t> protein array (</a:t>
            </a:r>
            <a:r>
              <a:rPr lang="en-US" sz="1400" dirty="0" err="1"/>
              <a:t>RayBiotech</a:t>
            </a:r>
            <a:r>
              <a:rPr lang="en-US" sz="1400" dirty="0"/>
              <a:t>) analysis was conducted </a:t>
            </a:r>
            <a:r>
              <a:rPr lang="en-US" sz="1400" dirty="0" smtClean="0"/>
              <a:t>to </a:t>
            </a:r>
            <a:r>
              <a:rPr lang="en-US" sz="1400" dirty="0"/>
              <a:t>profile interleukin and cytokine secretion from breast cancer cells </a:t>
            </a:r>
            <a:r>
              <a:rPr lang="en-US" sz="1400" dirty="0" smtClean="0"/>
              <a:t>transfected with </a:t>
            </a:r>
            <a:r>
              <a:rPr lang="en-US" sz="1400" dirty="0"/>
              <a:t>control or Gα12QL vectors. (B) Layout of proteins represented in each section by their corresponding </a:t>
            </a:r>
            <a:r>
              <a:rPr lang="en-US" sz="1400" dirty="0" smtClean="0"/>
              <a:t>antibodies. </a:t>
            </a:r>
            <a:r>
              <a:rPr lang="en-US" sz="1400" dirty="0"/>
              <a:t>(C) Experimental layout of samples.  See the legend to Fig. 3 and Materials and Methods for experimental details.</a:t>
            </a:r>
          </a:p>
        </p:txBody>
      </p:sp>
    </p:spTree>
    <p:extLst>
      <p:ext uri="{BB962C8B-B14F-4D97-AF65-F5344CB8AC3E}">
        <p14:creationId xmlns:p14="http://schemas.microsoft.com/office/powerpoint/2010/main" val="1146429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3674340" y="1055132"/>
          <a:ext cx="2209800" cy="214527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04900"/>
                <a:gridCol w="1104900"/>
              </a:tblGrid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POS1 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POS2</a:t>
                      </a:r>
                      <a:endParaRPr lang="en-US" sz="1400" b="0" dirty="0"/>
                    </a:p>
                  </a:txBody>
                  <a:tcPr/>
                </a:tc>
              </a:tr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1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2</a:t>
                      </a:r>
                      <a:endParaRPr lang="en-US" sz="1400" b="0" dirty="0"/>
                    </a:p>
                  </a:txBody>
                  <a:tcPr/>
                </a:tc>
              </a:tr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3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8</a:t>
                      </a:r>
                      <a:endParaRPr lang="en-US" sz="1400" b="0" dirty="0"/>
                    </a:p>
                  </a:txBody>
                  <a:tcPr/>
                </a:tc>
              </a:tr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9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10</a:t>
                      </a:r>
                      <a:endParaRPr lang="en-US" sz="1400" b="0" dirty="0"/>
                    </a:p>
                  </a:txBody>
                  <a:tcPr/>
                </a:tc>
              </a:tr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MMP-13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TIMP-1</a:t>
                      </a:r>
                      <a:endParaRPr lang="en-US" sz="1400" b="0" dirty="0"/>
                    </a:p>
                  </a:txBody>
                  <a:tcPr/>
                </a:tc>
              </a:tr>
              <a:tr h="357545"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TIMP-2</a:t>
                      </a:r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/>
                        <a:t>TIMP-4</a:t>
                      </a:r>
                      <a:endParaRPr lang="en-US" sz="1400" b="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051" name="Picture 3" descr="C:\Users\gmscyc\Desktop\Crystal\Raybiotech\2 Aug 2011\MMP Array 1\MMP 800_(#1_532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12140" y="369332"/>
            <a:ext cx="1523999" cy="4941912"/>
          </a:xfrm>
          <a:prstGeom prst="rect">
            <a:avLst/>
          </a:prstGeom>
          <a:noFill/>
        </p:spPr>
      </p:pic>
      <p:sp>
        <p:nvSpPr>
          <p:cNvPr id="11" name="Rectangle 10"/>
          <p:cNvSpPr/>
          <p:nvPr/>
        </p:nvSpPr>
        <p:spPr>
          <a:xfrm>
            <a:off x="304800" y="5751493"/>
            <a:ext cx="8382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S2. Human MMP array 1.</a:t>
            </a:r>
            <a:r>
              <a:rPr lang="en-US" sz="1400" dirty="0" smtClean="0"/>
              <a:t> (A) Original full </a:t>
            </a:r>
            <a:r>
              <a:rPr lang="en-US" sz="1400" dirty="0" err="1" smtClean="0"/>
              <a:t>Quantibody</a:t>
            </a:r>
            <a:r>
              <a:rPr lang="en-US" sz="1400" dirty="0" smtClean="0"/>
              <a:t> protein array (RayBiotech) analysis was conducted to profile MMP from breast cancer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control or Gα12QL vectors. (B) Layout of proteins represented in each section by their corresponding antibodies. (C) Experimental layout of samples. See the legend to Fig. 3 and Materials and Methods for experimental details.</a:t>
            </a:r>
            <a:endParaRPr lang="en-US" sz="1400" dirty="0"/>
          </a:p>
        </p:txBody>
      </p:sp>
      <p:sp>
        <p:nvSpPr>
          <p:cNvPr id="10" name="Right Brace 9"/>
          <p:cNvSpPr/>
          <p:nvPr/>
        </p:nvSpPr>
        <p:spPr>
          <a:xfrm>
            <a:off x="2912340" y="1043464"/>
            <a:ext cx="76200" cy="5334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3064740" y="1055132"/>
            <a:ext cx="609600" cy="21693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988540" y="1359932"/>
            <a:ext cx="609600" cy="176426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762000" y="304800"/>
            <a:ext cx="6324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                                            B				C</a:t>
            </a:r>
          </a:p>
        </p:txBody>
      </p:sp>
      <p:grpSp>
        <p:nvGrpSpPr>
          <p:cNvPr id="3" name="Group 131"/>
          <p:cNvGrpSpPr/>
          <p:nvPr/>
        </p:nvGrpSpPr>
        <p:grpSpPr>
          <a:xfrm>
            <a:off x="6781800" y="369332"/>
            <a:ext cx="1600200" cy="5181600"/>
            <a:chOff x="7010400" y="838200"/>
            <a:chExt cx="1600200" cy="5181600"/>
          </a:xfrm>
        </p:grpSpPr>
        <p:grpSp>
          <p:nvGrpSpPr>
            <p:cNvPr id="4" name="Group 82"/>
            <p:cNvGrpSpPr/>
            <p:nvPr/>
          </p:nvGrpSpPr>
          <p:grpSpPr>
            <a:xfrm>
              <a:off x="7010400" y="838200"/>
              <a:ext cx="1600200" cy="5181600"/>
              <a:chOff x="7010400" y="838200"/>
              <a:chExt cx="1600200" cy="5181600"/>
            </a:xfrm>
          </p:grpSpPr>
          <p:grpSp>
            <p:nvGrpSpPr>
              <p:cNvPr id="5" name="Group 8"/>
              <p:cNvGrpSpPr/>
              <p:nvPr/>
            </p:nvGrpSpPr>
            <p:grpSpPr>
              <a:xfrm>
                <a:off x="7010400" y="838200"/>
                <a:ext cx="1600200" cy="5181600"/>
                <a:chOff x="304800" y="685800"/>
                <a:chExt cx="1600200" cy="5181600"/>
              </a:xfrm>
            </p:grpSpPr>
            <p:sp>
              <p:nvSpPr>
                <p:cNvPr id="101" name="Rectangle 100"/>
                <p:cNvSpPr/>
                <p:nvPr/>
              </p:nvSpPr>
              <p:spPr>
                <a:xfrm>
                  <a:off x="304800" y="685800"/>
                  <a:ext cx="1600200" cy="5181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6" name="Group 16"/>
                <p:cNvGrpSpPr/>
                <p:nvPr/>
              </p:nvGrpSpPr>
              <p:grpSpPr>
                <a:xfrm>
                  <a:off x="446183" y="806068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24" name="Rectangle 123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5" name="Rectangle 124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7" name="Group 18"/>
                <p:cNvGrpSpPr/>
                <p:nvPr/>
              </p:nvGrpSpPr>
              <p:grpSpPr>
                <a:xfrm>
                  <a:off x="436085" y="1426685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22" name="Rectangle 121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3" name="Rectangle 122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8" name="Group 21"/>
                <p:cNvGrpSpPr/>
                <p:nvPr/>
              </p:nvGrpSpPr>
              <p:grpSpPr>
                <a:xfrm>
                  <a:off x="435166" y="2037204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20" name="Rectangle 119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1" name="Rectangle 120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9" name="Group 24"/>
                <p:cNvGrpSpPr/>
                <p:nvPr/>
              </p:nvGrpSpPr>
              <p:grpSpPr>
                <a:xfrm>
                  <a:off x="436085" y="2690872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8" name="Rectangle 117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4" name="Group 27"/>
                <p:cNvGrpSpPr/>
                <p:nvPr/>
              </p:nvGrpSpPr>
              <p:grpSpPr>
                <a:xfrm>
                  <a:off x="446183" y="3341783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6" name="Rectangle 27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6" name="Group 30"/>
                <p:cNvGrpSpPr/>
                <p:nvPr/>
              </p:nvGrpSpPr>
              <p:grpSpPr>
                <a:xfrm>
                  <a:off x="436085" y="3962400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4" name="Rectangle 25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5" name="Rectangle 26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7" name="Group 33"/>
                <p:cNvGrpSpPr/>
                <p:nvPr/>
              </p:nvGrpSpPr>
              <p:grpSpPr>
                <a:xfrm>
                  <a:off x="435166" y="4572919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2" name="Rectangle 23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3" name="Rectangle 24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8" name="Group 36"/>
                <p:cNvGrpSpPr/>
                <p:nvPr/>
              </p:nvGrpSpPr>
              <p:grpSpPr>
                <a:xfrm>
                  <a:off x="436085" y="5226587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0" name="Rectangle 21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1" name="Rectangle 22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85" name="TextBox 84"/>
              <p:cNvSpPr txBox="1"/>
              <p:nvPr/>
            </p:nvSpPr>
            <p:spPr>
              <a:xfrm>
                <a:off x="7042532" y="1100770"/>
                <a:ext cx="8382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CNTRL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7761383" y="1045685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7032434" y="1661837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7750366" y="1666302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7031515" y="2200870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scRNA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7749447" y="2205335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2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7032434" y="2843521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9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7750366" y="2841434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scRNA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7043451" y="3506368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2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7772400" y="3516217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9</a:t>
                </a:r>
              </a:p>
            </p:txBody>
          </p:sp>
        </p:grpSp>
        <p:sp>
          <p:nvSpPr>
            <p:cNvPr id="126" name="TextBox 125"/>
            <p:cNvSpPr txBox="1"/>
            <p:nvPr/>
          </p:nvSpPr>
          <p:spPr>
            <a:xfrm>
              <a:off x="7031515" y="4129340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scRN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7749447" y="4133805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2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7032434" y="4738940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9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7750366" y="4736853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scRN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043451" y="5401787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2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7772400" y="5411636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46065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C:\Users\gmscyc\Desktop\Crystal\Raybiotech\2 Aug 2011\Inflammation Array 3\INF 750_(#1_532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74392" y="369332"/>
            <a:ext cx="1611608" cy="5226004"/>
          </a:xfrm>
          <a:prstGeom prst="rect">
            <a:avLst/>
          </a:prstGeom>
          <a:noFill/>
        </p:spPr>
      </p:pic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3276600" y="359172"/>
          <a:ext cx="3429000" cy="5191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3000"/>
                <a:gridCol w="1143000"/>
                <a:gridCol w="1143000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POS1	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POS2</a:t>
                      </a:r>
                      <a:endParaRPr lang="en-US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BLC</a:t>
                      </a:r>
                      <a:endParaRPr lang="en-US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Eotaxin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Eotaxin-2	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-CSF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M-CS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-3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CAM-1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FN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γ</a:t>
                      </a:r>
                      <a:endParaRPr lang="en-US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α</a:t>
                      </a:r>
                      <a:endParaRPr lang="en-US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β</a:t>
                      </a:r>
                      <a:endParaRPr lang="en-US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ra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2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4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5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6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6sR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7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8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0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1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2p40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2p70</a:t>
                      </a:r>
                      <a:endParaRPr lang="en-US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3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5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6</a:t>
                      </a:r>
                      <a:endParaRPr lang="en-US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L-17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CP-1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CSF</a:t>
                      </a:r>
                      <a:endParaRPr lang="en-US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G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P-1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α</a:t>
                      </a:r>
                      <a:endParaRPr lang="en-US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P-1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β</a:t>
                      </a:r>
                      <a:endParaRPr lang="en-US" b="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P-1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δ</a:t>
                      </a:r>
                      <a:endParaRPr lang="en-US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DGF-BB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RANTES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IMP-1	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IMP-2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NF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α</a:t>
                      </a:r>
                      <a:endParaRPr lang="en-US" b="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NF</a:t>
                      </a:r>
                      <a:r>
                        <a:rPr lang="el-GR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/>
                        </a:rPr>
                        <a:t>β</a:t>
                      </a: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	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NF RI</a:t>
                      </a:r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NF RII</a:t>
                      </a:r>
                      <a:endParaRPr lang="en-US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304800" y="228600"/>
            <a:ext cx="7391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                                            B					  C</a:t>
            </a:r>
          </a:p>
        </p:txBody>
      </p:sp>
      <p:sp>
        <p:nvSpPr>
          <p:cNvPr id="11" name="Right Brace 10"/>
          <p:cNvSpPr/>
          <p:nvPr/>
        </p:nvSpPr>
        <p:spPr>
          <a:xfrm>
            <a:off x="2362200" y="1055132"/>
            <a:ext cx="76200" cy="5334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2514600" y="445532"/>
            <a:ext cx="685800" cy="82653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438400" y="1359932"/>
            <a:ext cx="762000" cy="4191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381000" y="5791200"/>
            <a:ext cx="84582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S3. Human inflammation array 3.</a:t>
            </a:r>
            <a:r>
              <a:rPr lang="en-US" sz="1400" dirty="0" smtClean="0"/>
              <a:t> (A) A full </a:t>
            </a:r>
            <a:r>
              <a:rPr lang="en-US" sz="1400" dirty="0" err="1" smtClean="0"/>
              <a:t>Quantibody</a:t>
            </a:r>
            <a:r>
              <a:rPr lang="en-US" sz="1400" dirty="0" smtClean="0"/>
              <a:t> protein array (RayBiotech) analysis was conducted to miscellaneous cytokine secretion from breast cancer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control or Gα12QL vectors. (B) Layout of proteins represented in each section by their corresponding antibodies. (C) Experimental layout of samples. See the legend to Fig. 3 and Materials and Methods for experimental details.</a:t>
            </a:r>
            <a:endParaRPr lang="en-US" sz="1400" dirty="0"/>
          </a:p>
        </p:txBody>
      </p:sp>
      <p:grpSp>
        <p:nvGrpSpPr>
          <p:cNvPr id="2" name="Group 77"/>
          <p:cNvGrpSpPr/>
          <p:nvPr/>
        </p:nvGrpSpPr>
        <p:grpSpPr>
          <a:xfrm>
            <a:off x="7239000" y="369332"/>
            <a:ext cx="1600200" cy="5181600"/>
            <a:chOff x="7010400" y="838200"/>
            <a:chExt cx="1600200" cy="5181600"/>
          </a:xfrm>
        </p:grpSpPr>
        <p:grpSp>
          <p:nvGrpSpPr>
            <p:cNvPr id="3" name="Group 82"/>
            <p:cNvGrpSpPr/>
            <p:nvPr/>
          </p:nvGrpSpPr>
          <p:grpSpPr>
            <a:xfrm>
              <a:off x="7010400" y="838200"/>
              <a:ext cx="1600200" cy="5181600"/>
              <a:chOff x="7010400" y="838200"/>
              <a:chExt cx="1600200" cy="5181600"/>
            </a:xfrm>
          </p:grpSpPr>
          <p:grpSp>
            <p:nvGrpSpPr>
              <p:cNvPr id="4" name="Group 8"/>
              <p:cNvGrpSpPr/>
              <p:nvPr/>
            </p:nvGrpSpPr>
            <p:grpSpPr>
              <a:xfrm>
                <a:off x="7010400" y="838200"/>
                <a:ext cx="1600200" cy="5181600"/>
                <a:chOff x="304800" y="685800"/>
                <a:chExt cx="1600200" cy="5181600"/>
              </a:xfrm>
            </p:grpSpPr>
            <p:sp>
              <p:nvSpPr>
                <p:cNvPr id="97" name="Rectangle 96"/>
                <p:cNvSpPr/>
                <p:nvPr/>
              </p:nvSpPr>
              <p:spPr>
                <a:xfrm>
                  <a:off x="304800" y="685800"/>
                  <a:ext cx="1600200" cy="5181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5" name="Group 16"/>
                <p:cNvGrpSpPr/>
                <p:nvPr/>
              </p:nvGrpSpPr>
              <p:grpSpPr>
                <a:xfrm>
                  <a:off x="446183" y="806068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20" name="Rectangle 119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1" name="Rectangle 120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6" name="Group 18"/>
                <p:cNvGrpSpPr/>
                <p:nvPr/>
              </p:nvGrpSpPr>
              <p:grpSpPr>
                <a:xfrm>
                  <a:off x="436085" y="1426685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8" name="Rectangle 117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7" name="Group 21"/>
                <p:cNvGrpSpPr/>
                <p:nvPr/>
              </p:nvGrpSpPr>
              <p:grpSpPr>
                <a:xfrm>
                  <a:off x="435166" y="2037204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6" name="Rectangle 115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8" name="Group 100"/>
                <p:cNvGrpSpPr/>
                <p:nvPr/>
              </p:nvGrpSpPr>
              <p:grpSpPr>
                <a:xfrm>
                  <a:off x="436085" y="2690872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4" name="Rectangle 113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5" name="Rectangle 114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9" name="Group 27"/>
                <p:cNvGrpSpPr/>
                <p:nvPr/>
              </p:nvGrpSpPr>
              <p:grpSpPr>
                <a:xfrm>
                  <a:off x="446183" y="3341783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2" name="Rectangle 27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3" name="Rectangle 112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3" name="Group 30"/>
                <p:cNvGrpSpPr/>
                <p:nvPr/>
              </p:nvGrpSpPr>
              <p:grpSpPr>
                <a:xfrm>
                  <a:off x="436085" y="3962400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10" name="Rectangle 25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1" name="Rectangle 26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5" name="Group 33"/>
                <p:cNvGrpSpPr/>
                <p:nvPr/>
              </p:nvGrpSpPr>
              <p:grpSpPr>
                <a:xfrm>
                  <a:off x="435166" y="4572919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08" name="Rectangle 23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9" name="Rectangle 24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7" name="Group 36"/>
                <p:cNvGrpSpPr/>
                <p:nvPr/>
              </p:nvGrpSpPr>
              <p:grpSpPr>
                <a:xfrm>
                  <a:off x="436085" y="5226587"/>
                  <a:ext cx="1329370" cy="533400"/>
                  <a:chOff x="435166" y="762000"/>
                  <a:chExt cx="1329370" cy="533400"/>
                </a:xfrm>
              </p:grpSpPr>
              <p:sp>
                <p:nvSpPr>
                  <p:cNvPr id="106" name="Rectangle 21"/>
                  <p:cNvSpPr/>
                  <p:nvPr/>
                </p:nvSpPr>
                <p:spPr>
                  <a:xfrm>
                    <a:off x="43516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7" name="Rectangle 22"/>
                  <p:cNvSpPr/>
                  <p:nvPr/>
                </p:nvSpPr>
                <p:spPr>
                  <a:xfrm>
                    <a:off x="1154936" y="762000"/>
                    <a:ext cx="609600" cy="5334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87" name="TextBox 86"/>
              <p:cNvSpPr txBox="1"/>
              <p:nvPr/>
            </p:nvSpPr>
            <p:spPr>
              <a:xfrm>
                <a:off x="7042532" y="1100770"/>
                <a:ext cx="8382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CNTRL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7761383" y="1045685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7032434" y="1661837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7750366" y="1666302"/>
                <a:ext cx="8382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tandard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7031515" y="2200870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scRNA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7749447" y="2205335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2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7032434" y="2843521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ck 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9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7750366" y="2841434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scRNA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7043451" y="3506368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2</a:t>
                </a: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7772400" y="3516217"/>
                <a:ext cx="838200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CF10A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l-GR" sz="900" dirty="0" smtClean="0">
                    <a:latin typeface="Times New Roman" pitchFamily="18" charset="0"/>
                    <a:cs typeface="Times New Roman" pitchFamily="18" charset="0"/>
                  </a:rPr>
                  <a:t>α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12QL</a:t>
                </a:r>
              </a:p>
              <a:p>
                <a:pPr algn="ctr"/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siMMP-9</a:t>
                </a:r>
              </a:p>
            </p:txBody>
          </p:sp>
        </p:grpSp>
        <p:sp>
          <p:nvSpPr>
            <p:cNvPr id="80" name="TextBox 79"/>
            <p:cNvSpPr txBox="1"/>
            <p:nvPr/>
          </p:nvSpPr>
          <p:spPr>
            <a:xfrm>
              <a:off x="7031515" y="4129340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scRN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7749447" y="4133805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2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032434" y="4738940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Mock 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9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7750366" y="4736853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scRN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7043451" y="5401787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2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7772400" y="5411636"/>
              <a:ext cx="83820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MDA-MB-231 G</a:t>
              </a:r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12QL</a:t>
              </a:r>
            </a:p>
            <a:p>
              <a:pPr algn="ctr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siMMP-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865914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896303" y="268718"/>
            <a:ext cx="3527762" cy="3388882"/>
            <a:chOff x="1229746" y="432315"/>
            <a:chExt cx="3658071" cy="3530085"/>
          </a:xfrm>
        </p:grpSpPr>
        <p:grpSp>
          <p:nvGrpSpPr>
            <p:cNvPr id="4" name="Group 3"/>
            <p:cNvGrpSpPr/>
            <p:nvPr/>
          </p:nvGrpSpPr>
          <p:grpSpPr>
            <a:xfrm>
              <a:off x="1229746" y="432315"/>
              <a:ext cx="3658071" cy="1701285"/>
              <a:chOff x="838200" y="1958975"/>
              <a:chExt cx="7848600" cy="4213225"/>
            </a:xfrm>
          </p:grpSpPr>
          <p:pic>
            <p:nvPicPr>
              <p:cNvPr id="6" name="Picture 2" descr="C:\Users\gmscyc\Desktop\MCF10A Inflammation Array 3 Mock and QL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926" t="1688" r="54630" b="8737"/>
              <a:stretch>
                <a:fillRect/>
              </a:stretch>
            </p:blipFill>
            <p:spPr bwMode="auto">
              <a:xfrm>
                <a:off x="838200" y="1958975"/>
                <a:ext cx="3810000" cy="4213225"/>
              </a:xfrm>
              <a:prstGeom prst="rect">
                <a:avLst/>
              </a:prstGeom>
              <a:noFill/>
            </p:spPr>
          </p:pic>
          <p:pic>
            <p:nvPicPr>
              <p:cNvPr id="7" name="Picture 2" descr="C:\Users\gmscyc\Desktop\MCF10A Inflammation Array 3 Mock and QL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52778" t="1688" r="926" b="5497"/>
              <a:stretch>
                <a:fillRect/>
              </a:stretch>
            </p:blipFill>
            <p:spPr bwMode="auto">
              <a:xfrm>
                <a:off x="4876800" y="1981200"/>
                <a:ext cx="3810000" cy="4191000"/>
              </a:xfrm>
              <a:prstGeom prst="rect">
                <a:avLst/>
              </a:prstGeom>
              <a:noFill/>
            </p:spPr>
          </p:pic>
          <p:grpSp>
            <p:nvGrpSpPr>
              <p:cNvPr id="8" name="Group 9"/>
              <p:cNvGrpSpPr/>
              <p:nvPr/>
            </p:nvGrpSpPr>
            <p:grpSpPr>
              <a:xfrm>
                <a:off x="2177668" y="3578130"/>
                <a:ext cx="1077817" cy="525653"/>
                <a:chOff x="2427383" y="3455797"/>
                <a:chExt cx="839691" cy="430403"/>
              </a:xfrm>
            </p:grpSpPr>
            <p:sp>
              <p:nvSpPr>
                <p:cNvPr id="12" name="Rectangle 11"/>
                <p:cNvSpPr/>
                <p:nvPr/>
              </p:nvSpPr>
              <p:spPr>
                <a:xfrm>
                  <a:off x="2427383" y="3679634"/>
                  <a:ext cx="838200" cy="20656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2428874" y="3455797"/>
                  <a:ext cx="838200" cy="20656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9" name="Group 13"/>
              <p:cNvGrpSpPr/>
              <p:nvPr/>
            </p:nvGrpSpPr>
            <p:grpSpPr>
              <a:xfrm>
                <a:off x="6215349" y="3581400"/>
                <a:ext cx="1077817" cy="525653"/>
                <a:chOff x="2427383" y="3455797"/>
                <a:chExt cx="839691" cy="430403"/>
              </a:xfrm>
            </p:grpSpPr>
            <p:sp>
              <p:nvSpPr>
                <p:cNvPr id="10" name="Rectangle 9"/>
                <p:cNvSpPr/>
                <p:nvPr/>
              </p:nvSpPr>
              <p:spPr>
                <a:xfrm>
                  <a:off x="2427383" y="3679634"/>
                  <a:ext cx="838200" cy="20656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Rectangle 10"/>
                <p:cNvSpPr/>
                <p:nvPr/>
              </p:nvSpPr>
              <p:spPr>
                <a:xfrm>
                  <a:off x="2428874" y="3455797"/>
                  <a:ext cx="838200" cy="20656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15" name="Group 14"/>
            <p:cNvGrpSpPr/>
            <p:nvPr/>
          </p:nvGrpSpPr>
          <p:grpSpPr>
            <a:xfrm>
              <a:off x="1253035" y="2286000"/>
              <a:ext cx="3623765" cy="1676400"/>
              <a:chOff x="990600" y="2514600"/>
              <a:chExt cx="6927247" cy="2590800"/>
            </a:xfrm>
          </p:grpSpPr>
          <p:pic>
            <p:nvPicPr>
              <p:cNvPr id="16" name="Picture 4" descr="C:\Users\gmscyc\Desktop\MCF10A MMP array 1 Mock and QL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3835" t="6486" r="54921" b="15262"/>
              <a:stretch>
                <a:fillRect/>
              </a:stretch>
            </p:blipFill>
            <p:spPr bwMode="auto">
              <a:xfrm>
                <a:off x="990600" y="2514600"/>
                <a:ext cx="3352800" cy="2590800"/>
              </a:xfrm>
              <a:prstGeom prst="rect">
                <a:avLst/>
              </a:prstGeom>
              <a:noFill/>
            </p:spPr>
          </p:pic>
          <p:pic>
            <p:nvPicPr>
              <p:cNvPr id="17" name="Picture 4" descr="C:\Users\gmscyc\Desktop\MCF10A MMP array 1 Mock and QL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54341" t="3331" r="4134" b="17883"/>
              <a:stretch>
                <a:fillRect/>
              </a:stretch>
            </p:blipFill>
            <p:spPr bwMode="auto">
              <a:xfrm>
                <a:off x="4565048" y="2514600"/>
                <a:ext cx="3352799" cy="2590800"/>
              </a:xfrm>
              <a:prstGeom prst="rect">
                <a:avLst/>
              </a:prstGeom>
              <a:noFill/>
            </p:spPr>
          </p:pic>
          <p:sp>
            <p:nvSpPr>
              <p:cNvPr id="18" name="Rectangle 17"/>
              <p:cNvSpPr/>
              <p:nvPr/>
            </p:nvSpPr>
            <p:spPr>
              <a:xfrm>
                <a:off x="2667000" y="3102168"/>
                <a:ext cx="1447800" cy="29378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6261643" y="3124201"/>
                <a:ext cx="1447799" cy="29378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25" name="Rectangle 24"/>
          <p:cNvSpPr/>
          <p:nvPr/>
        </p:nvSpPr>
        <p:spPr>
          <a:xfrm>
            <a:off x="5410200" y="457200"/>
            <a:ext cx="3352800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S4. </a:t>
            </a:r>
            <a:r>
              <a:rPr lang="en-US" sz="1400" b="1" dirty="0"/>
              <a:t>Expression of dominant active Gα12 in </a:t>
            </a:r>
            <a:r>
              <a:rPr lang="en-US" sz="1400" b="1" dirty="0" smtClean="0"/>
              <a:t>MCF10A </a:t>
            </a:r>
            <a:r>
              <a:rPr lang="en-US" sz="1400" b="1" dirty="0"/>
              <a:t>cells induces secretion of cytokines IL-6 and IL-8, and MMP-2. </a:t>
            </a:r>
            <a:r>
              <a:rPr lang="en-US" sz="1400" dirty="0"/>
              <a:t>(A) Protein array analysis of factors present in conditioned media. </a:t>
            </a:r>
            <a:r>
              <a:rPr lang="en-US" sz="1400" dirty="0" smtClean="0"/>
              <a:t>MCF10A </a:t>
            </a:r>
            <a:r>
              <a:rPr lang="en-US" sz="1400" dirty="0"/>
              <a:t>cells were </a:t>
            </a:r>
            <a:r>
              <a:rPr lang="en-US" sz="1400" dirty="0" err="1"/>
              <a:t>transfected</a:t>
            </a:r>
            <a:r>
              <a:rPr lang="en-US" sz="1400" dirty="0"/>
              <a:t> either with control vector (Mock) or Gα12QL as indicated. Following a </a:t>
            </a:r>
            <a:r>
              <a:rPr lang="en-US" sz="1400" dirty="0" smtClean="0"/>
              <a:t>72h </a:t>
            </a:r>
            <a:r>
              <a:rPr lang="en-US" sz="1400" dirty="0"/>
              <a:t>incubation, media was harvested and subject to antibody-based arrays; see Materials and Methods for details. </a:t>
            </a:r>
            <a:r>
              <a:rPr lang="en-US" sz="1400" dirty="0" smtClean="0"/>
              <a:t>(B). Quantification of relative densities of dots representing IL-6, IL-8 and MMP-2 in quadruplicates using </a:t>
            </a:r>
            <a:r>
              <a:rPr lang="en-US" sz="1400" dirty="0" err="1" smtClean="0"/>
              <a:t>TotaLab</a:t>
            </a:r>
            <a:r>
              <a:rPr lang="en-US" sz="1400" dirty="0" smtClean="0"/>
              <a:t> 2.0 program. Results were obtained from 3 chip-arrays each having two replicas of conditioned media. Bars </a:t>
            </a:r>
            <a:r>
              <a:rPr lang="en-US" sz="1400" dirty="0"/>
              <a:t>represent the mean ± S.E. of quadruplicate </a:t>
            </a:r>
            <a:r>
              <a:rPr lang="en-US" sz="1400" dirty="0" smtClean="0"/>
              <a:t>determinations; * (p &lt; 0.05).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1332523" y="27801"/>
            <a:ext cx="2786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  Mock                                    G</a:t>
            </a:r>
            <a:r>
              <a:rPr lang="el-GR" sz="1200" dirty="0" smtClean="0">
                <a:cs typeface="Arial"/>
              </a:rPr>
              <a:t>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2QL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69635" y="810750"/>
            <a:ext cx="685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L-6</a:t>
            </a:r>
          </a:p>
          <a:p>
            <a:pPr>
              <a:lnSpc>
                <a:spcPts val="12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L-8</a:t>
            </a:r>
          </a:p>
        </p:txBody>
      </p:sp>
      <p:sp>
        <p:nvSpPr>
          <p:cNvPr id="29" name="Rectangle 28"/>
          <p:cNvSpPr/>
          <p:nvPr/>
        </p:nvSpPr>
        <p:spPr>
          <a:xfrm rot="16200000">
            <a:off x="-109622" y="818942"/>
            <a:ext cx="159530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Human Inflammation </a:t>
            </a:r>
          </a:p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rray-3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Rectangle 29"/>
          <p:cNvSpPr/>
          <p:nvPr/>
        </p:nvSpPr>
        <p:spPr>
          <a:xfrm rot="16200000">
            <a:off x="180758" y="2588456"/>
            <a:ext cx="106702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uman MMP </a:t>
            </a:r>
          </a:p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rray-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369637" y="2399007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MP-2</a:t>
            </a:r>
          </a:p>
        </p:txBody>
      </p:sp>
      <p:pic>
        <p:nvPicPr>
          <p:cNvPr id="2" name="Picture 2" descr="C:\Users\Crystal\Pictures\Supp S4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7200" y="3733799"/>
            <a:ext cx="4114800" cy="2991351"/>
          </a:xfrm>
          <a:prstGeom prst="rect">
            <a:avLst/>
          </a:prstGeom>
          <a:noFill/>
        </p:spPr>
      </p:pic>
      <p:sp>
        <p:nvSpPr>
          <p:cNvPr id="31" name="Rectangle 30"/>
          <p:cNvSpPr/>
          <p:nvPr/>
        </p:nvSpPr>
        <p:spPr>
          <a:xfrm>
            <a:off x="537865" y="0"/>
            <a:ext cx="381000" cy="40421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2200"/>
              </a:lnSpc>
            </a:pPr>
            <a:r>
              <a:rPr lang="en-US" dirty="0" smtClean="0"/>
              <a:t>A</a:t>
            </a:r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endParaRPr lang="en-US" dirty="0"/>
          </a:p>
          <a:p>
            <a:pPr>
              <a:lnSpc>
                <a:spcPts val="2200"/>
              </a:lnSpc>
            </a:pPr>
            <a:endParaRPr lang="en-US" dirty="0" smtClean="0"/>
          </a:p>
          <a:p>
            <a:pPr>
              <a:lnSpc>
                <a:spcPts val="2200"/>
              </a:lnSpc>
            </a:pPr>
            <a:r>
              <a:rPr lang="en-US" dirty="0" smtClean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325013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Crystal\Pictures\Supp S5B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5800" y="4572000"/>
            <a:ext cx="1895475" cy="2162175"/>
          </a:xfrm>
          <a:prstGeom prst="rect">
            <a:avLst/>
          </a:prstGeom>
          <a:noFill/>
        </p:spPr>
      </p:pic>
      <p:pic>
        <p:nvPicPr>
          <p:cNvPr id="1026" name="Picture 2" descr="C:\Users\Crystal\Pictures\Supp S5C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971800" y="4267200"/>
            <a:ext cx="1924050" cy="2505075"/>
          </a:xfrm>
          <a:prstGeom prst="rect">
            <a:avLst/>
          </a:prstGeom>
          <a:noFill/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/>
          <a:srcRect t="12121" r="42800" b="27274"/>
          <a:stretch>
            <a:fillRect/>
          </a:stretch>
        </p:blipFill>
        <p:spPr bwMode="auto">
          <a:xfrm>
            <a:off x="381000" y="381000"/>
            <a:ext cx="2133600" cy="12930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Group 14"/>
          <p:cNvGrpSpPr/>
          <p:nvPr/>
        </p:nvGrpSpPr>
        <p:grpSpPr>
          <a:xfrm>
            <a:off x="685800" y="1676400"/>
            <a:ext cx="1676400" cy="3009320"/>
            <a:chOff x="4648200" y="1426266"/>
            <a:chExt cx="1737449" cy="3221934"/>
          </a:xfrm>
        </p:grpSpPr>
        <p:grpSp>
          <p:nvGrpSpPr>
            <p:cNvPr id="3" name="Group 7"/>
            <p:cNvGrpSpPr/>
            <p:nvPr/>
          </p:nvGrpSpPr>
          <p:grpSpPr>
            <a:xfrm>
              <a:off x="4648200" y="1426266"/>
              <a:ext cx="1737449" cy="3069534"/>
              <a:chOff x="4648200" y="1426266"/>
              <a:chExt cx="1737449" cy="3069534"/>
            </a:xfrm>
          </p:grpSpPr>
          <p:pic>
            <p:nvPicPr>
              <p:cNvPr id="4" name="Picture 3" descr="Figure3A.jpg"/>
              <p:cNvPicPr>
                <a:picLocks noChangeAspect="1"/>
              </p:cNvPicPr>
              <p:nvPr/>
            </p:nvPicPr>
            <p:blipFill>
              <a:blip r:embed="rId5" cstate="print"/>
              <a:srcRect t="29579" r="50489" b="33447"/>
              <a:stretch>
                <a:fillRect/>
              </a:stretch>
            </p:blipFill>
            <p:spPr>
              <a:xfrm>
                <a:off x="4648200" y="2323686"/>
                <a:ext cx="1737449" cy="2172114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7" name="Picture 6" descr="Figure3A.jpg"/>
              <p:cNvPicPr>
                <a:picLocks noChangeAspect="1"/>
              </p:cNvPicPr>
              <p:nvPr/>
            </p:nvPicPr>
            <p:blipFill>
              <a:blip r:embed="rId5" cstate="print"/>
              <a:srcRect t="4437" r="50489" b="80774"/>
              <a:stretch>
                <a:fillRect/>
              </a:stretch>
            </p:blipFill>
            <p:spPr>
              <a:xfrm>
                <a:off x="4648200" y="1426266"/>
                <a:ext cx="1737449" cy="897420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13" name="Rectangle 12"/>
            <p:cNvSpPr/>
            <p:nvPr/>
          </p:nvSpPr>
          <p:spPr>
            <a:xfrm>
              <a:off x="5410200" y="4528850"/>
              <a:ext cx="762000" cy="1193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876800" y="4419600"/>
              <a:ext cx="228600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5" name="Picture 4" descr="Figure3B.jpg"/>
          <p:cNvPicPr>
            <a:picLocks noChangeAspect="1"/>
          </p:cNvPicPr>
          <p:nvPr/>
        </p:nvPicPr>
        <p:blipFill>
          <a:blip r:embed="rId6" cstate="print"/>
          <a:srcRect t="3993" r="54400" b="29454"/>
          <a:stretch>
            <a:fillRect/>
          </a:stretch>
        </p:blipFill>
        <p:spPr>
          <a:xfrm>
            <a:off x="3011014" y="228600"/>
            <a:ext cx="1676400" cy="4144432"/>
          </a:xfrm>
          <a:prstGeom prst="rect">
            <a:avLst/>
          </a:prstGeom>
          <a:ln>
            <a:noFill/>
          </a:ln>
        </p:spPr>
      </p:pic>
      <p:sp>
        <p:nvSpPr>
          <p:cNvPr id="20" name="Rectangle 19"/>
          <p:cNvSpPr/>
          <p:nvPr/>
        </p:nvSpPr>
        <p:spPr>
          <a:xfrm>
            <a:off x="304800" y="330875"/>
            <a:ext cx="5715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                                            C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r>
              <a:rPr lang="en-US" dirty="0" smtClean="0"/>
              <a:t> B</a:t>
            </a:r>
          </a:p>
        </p:txBody>
      </p:sp>
      <p:sp>
        <p:nvSpPr>
          <p:cNvPr id="21" name="Rectangle 20"/>
          <p:cNvSpPr/>
          <p:nvPr/>
        </p:nvSpPr>
        <p:spPr>
          <a:xfrm>
            <a:off x="4648200" y="1259466"/>
            <a:ext cx="652743" cy="3407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/>
              <a:t>MMP-2</a:t>
            </a:r>
            <a:endParaRPr lang="en-US" sz="1200" dirty="0"/>
          </a:p>
        </p:txBody>
      </p:sp>
      <p:sp>
        <p:nvSpPr>
          <p:cNvPr id="23" name="Right Bracket 22"/>
          <p:cNvSpPr/>
          <p:nvPr/>
        </p:nvSpPr>
        <p:spPr>
          <a:xfrm>
            <a:off x="4572000" y="1371600"/>
            <a:ext cx="76200" cy="2286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5715000" y="685800"/>
            <a:ext cx="2971801" cy="5478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S5. Validation of increased secretion of IL-8 and MMP-2 expression of MCF10A cells expressing dominant activate Gα12.</a:t>
            </a:r>
            <a:r>
              <a:rPr lang="en-US" sz="1400" dirty="0" smtClean="0"/>
              <a:t> (A) Expression of IL-8 in total cell </a:t>
            </a:r>
            <a:r>
              <a:rPr lang="en-US" sz="1400" dirty="0" err="1" smtClean="0"/>
              <a:t>lysates</a:t>
            </a:r>
            <a:r>
              <a:rPr lang="en-US" sz="1400" dirty="0" smtClean="0"/>
              <a:t> of MCF10A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mock (M) vector or Gα12QL (QL) vector. (B) MMP-2 levels in conditioned media of MCF10A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mock (M) vector or Gα12QL (QL) vector. (C) </a:t>
            </a:r>
            <a:r>
              <a:rPr lang="en-US" sz="1400" dirty="0" err="1" smtClean="0"/>
              <a:t>Zymography</a:t>
            </a:r>
            <a:r>
              <a:rPr lang="en-US" sz="1400" dirty="0" smtClean="0"/>
              <a:t> analysis of </a:t>
            </a:r>
            <a:r>
              <a:rPr lang="en-US" sz="1400" dirty="0" err="1" smtClean="0"/>
              <a:t>gelatinase</a:t>
            </a:r>
            <a:r>
              <a:rPr lang="en-US" sz="1400" dirty="0" smtClean="0"/>
              <a:t> activity of MMP-2 in conditioned media of MCF10A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mock (M) vector or Gα12QL (QL) vector.  Experimental conditions are as in (B).  In the center panel, aliquots of conditioned media from were analyzed  by silver-as the loading controls. Data in the lower panel are the are the mean ± S.E. of quadruplicate determinations from a single experiment that is representative of two independent experiments. </a:t>
            </a:r>
            <a:endParaRPr lang="en-US" sz="1400" dirty="0"/>
          </a:p>
        </p:txBody>
      </p:sp>
      <p:sp>
        <p:nvSpPr>
          <p:cNvPr id="17" name="Rectangle 16"/>
          <p:cNvSpPr/>
          <p:nvPr/>
        </p:nvSpPr>
        <p:spPr>
          <a:xfrm>
            <a:off x="2209800" y="2008910"/>
            <a:ext cx="652743" cy="3407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/>
              <a:t>MMP-2</a:t>
            </a:r>
            <a:endParaRPr lang="en-US" sz="1200" dirty="0"/>
          </a:p>
        </p:txBody>
      </p:sp>
      <p:sp>
        <p:nvSpPr>
          <p:cNvPr id="74" name="Rectangle 73"/>
          <p:cNvSpPr/>
          <p:nvPr/>
        </p:nvSpPr>
        <p:spPr>
          <a:xfrm rot="16200000">
            <a:off x="1245491" y="3402710"/>
            <a:ext cx="23580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ilver stained gels (loading control)</a:t>
            </a:r>
            <a:endParaRPr lang="en-US" sz="1200" dirty="0"/>
          </a:p>
        </p:txBody>
      </p:sp>
      <p:sp>
        <p:nvSpPr>
          <p:cNvPr id="75" name="Rectangle 74"/>
          <p:cNvSpPr/>
          <p:nvPr/>
        </p:nvSpPr>
        <p:spPr>
          <a:xfrm rot="16200000">
            <a:off x="3531491" y="3097911"/>
            <a:ext cx="23580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ilver stained gels (loading control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70927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111144" y="648707"/>
            <a:ext cx="4191000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S6.</a:t>
            </a:r>
            <a:r>
              <a:rPr lang="en-US" sz="1400" dirty="0" smtClean="0"/>
              <a:t> </a:t>
            </a:r>
            <a:r>
              <a:rPr lang="en-US" sz="1400" b="1" dirty="0" smtClean="0"/>
              <a:t>Analysis of MMP-2 activity upon Gα12QL expression by </a:t>
            </a:r>
            <a:r>
              <a:rPr lang="en-US" sz="1400" i="1" dirty="0" smtClean="0"/>
              <a:t>in-situ</a:t>
            </a:r>
            <a:r>
              <a:rPr lang="en-US" sz="1400" dirty="0" smtClean="0"/>
              <a:t> </a:t>
            </a:r>
            <a:r>
              <a:rPr lang="en-US" sz="1400" dirty="0" err="1" smtClean="0"/>
              <a:t>zymography</a:t>
            </a:r>
            <a:r>
              <a:rPr lang="en-US" sz="1400" dirty="0" smtClean="0"/>
              <a:t>. Secreted </a:t>
            </a:r>
            <a:r>
              <a:rPr lang="en-US" sz="1400" dirty="0" err="1" smtClean="0"/>
              <a:t>gelatinase</a:t>
            </a:r>
            <a:r>
              <a:rPr lang="en-US" sz="1400" dirty="0" smtClean="0"/>
              <a:t> activity in living MDA-MB-231 cells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mock or Gα12QL expression vectors is seen as the darkened areas. The corresponding lack of dark areas upon MMP-2 knockdown (</a:t>
            </a:r>
            <a:r>
              <a:rPr lang="en-US" sz="1400" dirty="0" err="1" smtClean="0"/>
              <a:t>siMMP</a:t>
            </a:r>
            <a:r>
              <a:rPr lang="en-US" sz="1400" dirty="0" smtClean="0"/>
              <a:t>) is also observed. The lower panel shows a </a:t>
            </a:r>
            <a:r>
              <a:rPr lang="en-US" sz="1400" dirty="0" err="1" smtClean="0"/>
              <a:t>quantitation</a:t>
            </a:r>
            <a:r>
              <a:rPr lang="en-US" sz="1400" dirty="0" smtClean="0"/>
              <a:t> of the relative </a:t>
            </a:r>
            <a:r>
              <a:rPr lang="en-US" sz="1400" dirty="0" err="1" smtClean="0"/>
              <a:t>gelatinase</a:t>
            </a:r>
            <a:r>
              <a:rPr lang="en-US" sz="1400" dirty="0" smtClean="0"/>
              <a:t> activity of all samples. Data represents the means +/- S.D. of triplicate determinations for a single experiment, which is representative of two such experiments.</a:t>
            </a:r>
          </a:p>
        </p:txBody>
      </p:sp>
      <p:grpSp>
        <p:nvGrpSpPr>
          <p:cNvPr id="2" name="Group 5"/>
          <p:cNvGrpSpPr/>
          <p:nvPr/>
        </p:nvGrpSpPr>
        <p:grpSpPr>
          <a:xfrm>
            <a:off x="680725" y="236841"/>
            <a:ext cx="2895600" cy="6324600"/>
            <a:chOff x="5715000" y="304800"/>
            <a:chExt cx="2895600" cy="6324600"/>
          </a:xfrm>
        </p:grpSpPr>
        <p:grpSp>
          <p:nvGrpSpPr>
            <p:cNvPr id="3" name="Group 30"/>
            <p:cNvGrpSpPr/>
            <p:nvPr/>
          </p:nvGrpSpPr>
          <p:grpSpPr>
            <a:xfrm>
              <a:off x="5715000" y="304800"/>
              <a:ext cx="2895600" cy="6324600"/>
              <a:chOff x="0" y="838200"/>
              <a:chExt cx="3276599" cy="6553200"/>
            </a:xfrm>
          </p:grpSpPr>
          <p:pic>
            <p:nvPicPr>
              <p:cNvPr id="15" name="Picture 14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r="32771"/>
              <a:stretch>
                <a:fillRect/>
              </a:stretch>
            </p:blipFill>
            <p:spPr bwMode="auto">
              <a:xfrm>
                <a:off x="619125" y="1264953"/>
                <a:ext cx="2657474" cy="40675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685800" y="838200"/>
                <a:ext cx="2514600" cy="3507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</a:t>
                </a:r>
                <a:r>
                  <a:rPr lang="en-US" sz="1600" dirty="0" err="1" smtClean="0"/>
                  <a:t>scRNA</a:t>
                </a:r>
                <a:r>
                  <a:rPr lang="en-US" sz="1600" dirty="0" smtClean="0"/>
                  <a:t>            siMMP-2</a:t>
                </a:r>
                <a:endParaRPr lang="en-US" sz="16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0" y="1295400"/>
                <a:ext cx="522410" cy="403860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dirty="0" smtClean="0"/>
                  <a:t>           Gα12QL                         Mock</a:t>
                </a:r>
                <a:endParaRPr lang="en-US" dirty="0"/>
              </a:p>
            </p:txBody>
          </p:sp>
          <p:pic>
            <p:nvPicPr>
              <p:cNvPr id="18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r="27139"/>
              <a:stretch>
                <a:fillRect/>
              </a:stretch>
            </p:blipFill>
            <p:spPr bwMode="auto">
              <a:xfrm>
                <a:off x="517358" y="5486399"/>
                <a:ext cx="2514600" cy="19050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7495" t="4675" r="80013" b="8289"/>
            <a:stretch>
              <a:fillRect/>
            </a:stretch>
          </p:blipFill>
          <p:spPr bwMode="auto">
            <a:xfrm>
              <a:off x="6382657" y="4800600"/>
              <a:ext cx="399143" cy="1676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6229350" y="5829300"/>
              <a:ext cx="3810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/>
                <a:t>100</a:t>
              </a:r>
              <a:endParaRPr lang="en-US" sz="10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229350" y="5410200"/>
              <a:ext cx="38100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/>
                <a:t>200</a:t>
              </a:r>
            </a:p>
            <a:p>
              <a:pPr algn="r"/>
              <a:endParaRPr lang="en-US" sz="1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229350" y="5000625"/>
              <a:ext cx="38100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/>
                <a:t>300</a:t>
              </a:r>
            </a:p>
            <a:p>
              <a:pPr algn="r"/>
              <a:endParaRPr lang="en-US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5448842" y="5504847"/>
              <a:ext cx="1373439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 smtClean="0"/>
                <a:t>Gelatinase</a:t>
              </a:r>
              <a:r>
                <a:rPr lang="en-US" sz="1000" dirty="0" smtClean="0"/>
                <a:t> activity </a:t>
              </a:r>
            </a:p>
            <a:p>
              <a:pPr algn="ctr"/>
              <a:r>
                <a:rPr lang="en-US" sz="1000" dirty="0" smtClean="0"/>
                <a:t>(% control)</a:t>
              </a:r>
              <a:endParaRPr lang="en-US" sz="1000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750050" y="4822634"/>
              <a:ext cx="167640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19987" t="4675" r="27139" b="82892"/>
            <a:stretch>
              <a:fillRect/>
            </a:stretch>
          </p:blipFill>
          <p:spPr bwMode="auto">
            <a:xfrm>
              <a:off x="6769395" y="4724400"/>
              <a:ext cx="161260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6574939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Crystal\Pictures\Supp S7A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514350"/>
            <a:ext cx="4267200" cy="4133850"/>
          </a:xfrm>
          <a:prstGeom prst="rect">
            <a:avLst/>
          </a:prstGeom>
          <a:noFill/>
        </p:spPr>
      </p:pic>
      <p:pic>
        <p:nvPicPr>
          <p:cNvPr id="1026" name="Picture 2" descr="C:\Users\Crystal\Pictures\Supp S7B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29150" y="457200"/>
            <a:ext cx="4286250" cy="4210050"/>
          </a:xfrm>
          <a:prstGeom prst="rect">
            <a:avLst/>
          </a:prstGeom>
          <a:noFill/>
        </p:spPr>
      </p:pic>
      <p:sp>
        <p:nvSpPr>
          <p:cNvPr id="72" name="Rectangle 71"/>
          <p:cNvSpPr/>
          <p:nvPr/>
        </p:nvSpPr>
        <p:spPr>
          <a:xfrm>
            <a:off x="228600" y="4953000"/>
            <a:ext cx="8686799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l Figure S7. Interleukins and MMP-2 are involved in Gα12-mediated invasion of MCF10A cells.</a:t>
            </a:r>
            <a:r>
              <a:rPr lang="en-US" sz="1400" dirty="0" smtClean="0"/>
              <a:t> </a:t>
            </a:r>
          </a:p>
          <a:p>
            <a:r>
              <a:rPr lang="en-US" sz="1400" dirty="0" smtClean="0"/>
              <a:t>MCF10A cells were 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control vector (Mock) or Gα12QL vectors as indicated, in addition, for (B) the cells were co-</a:t>
            </a:r>
            <a:r>
              <a:rPr lang="en-US" sz="1400" dirty="0" err="1" smtClean="0"/>
              <a:t>transfected</a:t>
            </a:r>
            <a:r>
              <a:rPr lang="en-US" sz="1400" dirty="0" smtClean="0"/>
              <a:t> with either scrambled (</a:t>
            </a:r>
            <a:r>
              <a:rPr lang="en-US" sz="1400" dirty="0" err="1" smtClean="0"/>
              <a:t>scRNA</a:t>
            </a:r>
            <a:r>
              <a:rPr lang="en-US" sz="1400" dirty="0" smtClean="0"/>
              <a:t>) or MMP-2 </a:t>
            </a:r>
            <a:r>
              <a:rPr lang="en-US" sz="1400" dirty="0" err="1" smtClean="0"/>
              <a:t>siRNA</a:t>
            </a:r>
            <a:r>
              <a:rPr lang="en-US" sz="1400" dirty="0" smtClean="0"/>
              <a:t>; the plasmid vectors also expressed GFP. The green cells were then sorted, and the enriched fractions subject to invasion assays (A) Addition of IL-6 and IL-8 specific antibodies resulted in reduced Gα12-stimulated cell invasion. Data is pooled from three independent experiments, each involving triplicate determinations. Bars represent the mean ± S.E.  (B) Depletion of MMP-2 with specific </a:t>
            </a:r>
            <a:r>
              <a:rPr lang="en-US" sz="1400" dirty="0" err="1" smtClean="0"/>
              <a:t>siRNA</a:t>
            </a:r>
            <a:r>
              <a:rPr lang="en-US" sz="1400" dirty="0" smtClean="0"/>
              <a:t> decreases Gα12-stimulated invasion of MCF10A cells. Data is pooled from three independent experiments, each involving duplicate determinations. For both panels, bars represent the mean ± S.E.; * (p &lt; 0.05).</a:t>
            </a:r>
            <a:endParaRPr lang="en-US" sz="1400" dirty="0"/>
          </a:p>
        </p:txBody>
      </p:sp>
      <p:sp>
        <p:nvSpPr>
          <p:cNvPr id="137" name="Rectangle 136"/>
          <p:cNvSpPr/>
          <p:nvPr/>
        </p:nvSpPr>
        <p:spPr>
          <a:xfrm>
            <a:off x="228600" y="457200"/>
            <a:ext cx="5029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                            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15184389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/>
          <p:cNvSpPr/>
          <p:nvPr/>
        </p:nvSpPr>
        <p:spPr>
          <a:xfrm>
            <a:off x="7192021" y="1295400"/>
            <a:ext cx="885179" cy="28623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IL-8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 smtClean="0"/>
          </a:p>
          <a:p>
            <a:r>
              <a:rPr lang="en-US" dirty="0" smtClean="0"/>
              <a:t>IL-6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MMP-2</a:t>
            </a:r>
            <a:endParaRPr lang="en-US" dirty="0"/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1172221" y="4010799"/>
            <a:ext cx="5715000" cy="278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1172221" y="3962400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6734821" y="3858399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6734821" y="3858399"/>
            <a:ext cx="228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2827061" y="3505200"/>
            <a:ext cx="38754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Oct1 AP-1  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                               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   TATA</a:t>
            </a:r>
            <a:endParaRPr lang="en-US" sz="1200" dirty="0"/>
          </a:p>
        </p:txBody>
      </p:sp>
      <p:sp>
        <p:nvSpPr>
          <p:cNvPr id="41" name="Rectangle 40"/>
          <p:cNvSpPr/>
          <p:nvPr/>
        </p:nvSpPr>
        <p:spPr>
          <a:xfrm>
            <a:off x="925044" y="4186535"/>
            <a:ext cx="60383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-1282                                               -580  -470  -395                                               -71           -35</a:t>
            </a:r>
            <a:endParaRPr lang="en-US" sz="1200" dirty="0"/>
          </a:p>
        </p:txBody>
      </p:sp>
      <p:sp>
        <p:nvSpPr>
          <p:cNvPr id="42" name="Rectangle 41"/>
          <p:cNvSpPr/>
          <p:nvPr/>
        </p:nvSpPr>
        <p:spPr>
          <a:xfrm>
            <a:off x="3077221" y="38100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3382021" y="3810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3763021" y="3810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5668021" y="38100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6277621" y="3810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1190798" y="2639199"/>
            <a:ext cx="5715000" cy="278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V="1">
            <a:off x="1190798" y="2590800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V="1">
            <a:off x="6753398" y="2486799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6753398" y="2486799"/>
            <a:ext cx="228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2010421" y="2057400"/>
            <a:ext cx="47458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AP-1                  NF-</a:t>
            </a:r>
            <a:r>
              <a:rPr lang="en-US" sz="1200" dirty="0" err="1" smtClean="0"/>
              <a:t>kB</a:t>
            </a:r>
            <a:r>
              <a:rPr lang="en-US" sz="1200" dirty="0" smtClean="0"/>
              <a:t>  CRE                                  NF-</a:t>
            </a:r>
            <a:r>
              <a:rPr lang="en-US" sz="1200" dirty="0" err="1" smtClean="0"/>
              <a:t>kB</a:t>
            </a:r>
            <a:r>
              <a:rPr lang="en-US" sz="1200" dirty="0" smtClean="0"/>
              <a:t> GATA 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    TATA </a:t>
            </a:r>
            <a:endParaRPr lang="en-US" sz="1200" dirty="0"/>
          </a:p>
        </p:txBody>
      </p:sp>
      <p:sp>
        <p:nvSpPr>
          <p:cNvPr id="57" name="Rectangle 56"/>
          <p:cNvSpPr/>
          <p:nvPr/>
        </p:nvSpPr>
        <p:spPr>
          <a:xfrm>
            <a:off x="943621" y="2814935"/>
            <a:ext cx="60383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-1200                  -900                     -330 -320                                     -114    -80    -70           -25</a:t>
            </a:r>
            <a:endParaRPr lang="en-US" sz="1200" dirty="0"/>
          </a:p>
        </p:txBody>
      </p:sp>
      <p:sp>
        <p:nvSpPr>
          <p:cNvPr id="58" name="Rectangle 57"/>
          <p:cNvSpPr/>
          <p:nvPr/>
        </p:nvSpPr>
        <p:spPr>
          <a:xfrm>
            <a:off x="3095798" y="24384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2086621" y="24384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3382021" y="24384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5686598" y="24384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6296198" y="24384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3" name="Straight Connector 62"/>
          <p:cNvCxnSpPr/>
          <p:nvPr/>
        </p:nvCxnSpPr>
        <p:spPr>
          <a:xfrm flipV="1">
            <a:off x="1324621" y="1343799"/>
            <a:ext cx="5715000" cy="278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flipV="1">
            <a:off x="1324621" y="1295400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V="1">
            <a:off x="6887221" y="1191399"/>
            <a:ext cx="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6887221" y="1191399"/>
            <a:ext cx="228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2979461" y="838200"/>
            <a:ext cx="38770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IRF    HNF              AP-1           NF-</a:t>
            </a:r>
            <a:r>
              <a:rPr lang="en-US" sz="1200" dirty="0" err="1" smtClean="0"/>
              <a:t>kB</a:t>
            </a:r>
            <a:r>
              <a:rPr lang="en-US" sz="1200" dirty="0" smtClean="0"/>
              <a:t>                     TATA</a:t>
            </a:r>
            <a:endParaRPr lang="en-US" sz="1200" dirty="0"/>
          </a:p>
        </p:txBody>
      </p:sp>
      <p:sp>
        <p:nvSpPr>
          <p:cNvPr id="68" name="Rectangle 67"/>
          <p:cNvSpPr/>
          <p:nvPr/>
        </p:nvSpPr>
        <p:spPr>
          <a:xfrm>
            <a:off x="1077444" y="1519535"/>
            <a:ext cx="60383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-1482                                               -580   -420  -370             -120          -90 -70                       -12</a:t>
            </a:r>
            <a:endParaRPr lang="en-US" sz="1200" dirty="0"/>
          </a:p>
        </p:txBody>
      </p:sp>
      <p:sp>
        <p:nvSpPr>
          <p:cNvPr id="69" name="Rectangle 68"/>
          <p:cNvSpPr/>
          <p:nvPr/>
        </p:nvSpPr>
        <p:spPr>
          <a:xfrm>
            <a:off x="3229621" y="11430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5287021" y="11430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4677421" y="1143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5515621" y="11430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6506221" y="1143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5363221" y="24384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5" name="Straight Connector 84"/>
          <p:cNvCxnSpPr/>
          <p:nvPr/>
        </p:nvCxnSpPr>
        <p:spPr>
          <a:xfrm flipV="1">
            <a:off x="2620021" y="2590800"/>
            <a:ext cx="76200" cy="1524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flipV="1">
            <a:off x="2543821" y="25908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flipV="1">
            <a:off x="2620021" y="25908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flipV="1">
            <a:off x="2467621" y="3962400"/>
            <a:ext cx="76200" cy="1524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flipV="1">
            <a:off x="2391421" y="39624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flipV="1">
            <a:off x="2467621" y="39624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Rectangle 90"/>
          <p:cNvSpPr/>
          <p:nvPr/>
        </p:nvSpPr>
        <p:spPr>
          <a:xfrm>
            <a:off x="4982221" y="2438400"/>
            <a:ext cx="1524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4" name="Straight Connector 93"/>
          <p:cNvCxnSpPr/>
          <p:nvPr/>
        </p:nvCxnSpPr>
        <p:spPr>
          <a:xfrm flipV="1">
            <a:off x="2696221" y="1295400"/>
            <a:ext cx="76200" cy="1524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flipV="1">
            <a:off x="2620021" y="12954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flipV="1">
            <a:off x="2696221" y="1295400"/>
            <a:ext cx="76200" cy="152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3915421" y="1143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3610621" y="1143000"/>
            <a:ext cx="152400" cy="381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76200" y="6019800"/>
            <a:ext cx="82296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8. Schematic representation of the transcription factor binding sites present in the </a:t>
            </a:r>
            <a:r>
              <a:rPr lang="en-US" sz="1400" b="1" dirty="0" err="1" smtClean="0"/>
              <a:t>the</a:t>
            </a:r>
            <a:r>
              <a:rPr lang="en-US" sz="1400" b="1" dirty="0" smtClean="0"/>
              <a:t> 5’ UTRs of the IL-6, IL-8, MMP-2 and MMP-9 promoters. </a:t>
            </a:r>
            <a:r>
              <a:rPr lang="en-US" sz="1400" dirty="0" smtClean="0"/>
              <a:t> Predicted binding sites for transcription factors on promoter regions of IL-6, IL-8 and MMP-2 genes are shown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42879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66</Words>
  <Application>Microsoft Office PowerPoint</Application>
  <PresentationFormat>On-screen Show (4:3)</PresentationFormat>
  <Paragraphs>239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msuuk</dc:creator>
  <cp:lastModifiedBy>gmsuuk</cp:lastModifiedBy>
  <cp:revision>1</cp:revision>
  <dcterms:created xsi:type="dcterms:W3CDTF">2013-10-14T06:59:01Z</dcterms:created>
  <dcterms:modified xsi:type="dcterms:W3CDTF">2013-10-14T07:03:53Z</dcterms:modified>
</cp:coreProperties>
</file>